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jpeg" ContentType="image/jpeg"/>
  <Override PartName="/ppt/media/image3.wmf" ContentType="image/x-wmf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BFEEC-2AEE-4006-A952-D9084EEE6D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EBDEC-0DEA-4A26-82A9-0E12B1011A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FED4E-2358-4A9E-814A-A5E5DB30E9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AD373-9C38-4B14-BCC3-A3B348E485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195CD-3A4B-4AAE-8BFA-12FD69A38B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50F9A-3618-4461-ACC2-06A2A455C9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DAB9D-D1D9-420B-96E1-6FAF02AE9C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59020-1D12-40F9-B138-07A8F5106A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DE039-E34B-4ACC-BC6C-2E61B7C20D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951AA0-4D7E-4F8A-BA8F-69D874E26A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85183-913C-40E6-AD79-091186D704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02FE7-095A-4EEE-98E7-0EF852A5CB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04CD6C-E8A1-4A82-B486-A79A501206E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jpeg"/><Relationship Id="rId4" Type="http://schemas.openxmlformats.org/officeDocument/2006/relationships/package" Target="../embeddings/oleObject2.xlsx"/><Relationship Id="rId5" Type="http://schemas.openxmlformats.org/officeDocument/2006/relationships/image" Target="../media/image3.wmf"/><Relationship Id="rId6" Type="http://schemas.openxmlformats.org/officeDocument/2006/relationships/image" Target="../media/image4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611880" y="674640"/>
            <a:ext cx="2918880" cy="4815000"/>
            <a:chOff x="3611880" y="674640"/>
            <a:chExt cx="2918880" cy="4815000"/>
          </a:xfrm>
        </p:grpSpPr>
        <p:graphicFrame>
          <p:nvGraphicFramePr>
            <p:cNvPr id="42" name=""/>
            <p:cNvGraphicFramePr/>
            <p:nvPr/>
          </p:nvGraphicFramePr>
          <p:xfrm>
            <a:off x="4249440" y="1101600"/>
            <a:ext cx="2158920" cy="21585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4249440" y="1101600"/>
                      <a:ext cx="2158920" cy="2158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3654000" y="813960"/>
              <a:ext cx="379440" cy="228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TEV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AA1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974760" y="2274480"/>
              <a:ext cx="327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001760" y="1572840"/>
              <a:ext cx="349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001760" y="917280"/>
              <a:ext cx="349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flipV="1">
              <a:off x="4284360" y="1055160"/>
              <a:ext cx="0" cy="1007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889080" y="674640"/>
              <a:ext cx="61452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O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4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249440" y="2830320"/>
              <a:ext cx="215892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9056600">
              <a:off x="3597120" y="3354480"/>
              <a:ext cx="1295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n inoculated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9056600">
              <a:off x="4336920" y="3257640"/>
              <a:ext cx="1008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oculated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9056600">
              <a:off x="4566600" y="3449880"/>
              <a:ext cx="1512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Yolo Wond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9056600">
              <a:off x="5122080" y="3344760"/>
              <a:ext cx="1513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lorida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r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5" name="" descr=""/>
            <p:cNvPicPr/>
            <p:nvPr/>
          </p:nvPicPr>
          <p:blipFill>
            <a:blip r:embed="rId3"/>
            <a:stretch/>
          </p:blipFill>
          <p:spPr>
            <a:xfrm>
              <a:off x="4014360" y="4066920"/>
              <a:ext cx="2159280" cy="1391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"/>
            <p:cNvSpPr/>
            <p:nvPr/>
          </p:nvSpPr>
          <p:spPr>
            <a:xfrm>
              <a:off x="5070240" y="4086000"/>
              <a:ext cx="0" cy="136800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952440" y="5213160"/>
              <a:ext cx="93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YW : </a:t>
              </a:r>
              <a:r>
                <a:rPr b="1" i="1" lang="en-US" sz="1200" spc="-1" strike="noStrike">
                  <a:solidFill>
                    <a:srgbClr val="ffffff"/>
                  </a:solidFill>
                  <a:latin typeface="Arial"/>
                </a:rPr>
                <a:t>pvr2</a:t>
              </a:r>
              <a:r>
                <a:rPr b="1" i="1" lang="en-US" sz="1200" spc="-1" strike="noStrike" baseline="30000">
                  <a:solidFill>
                    <a:srgbClr val="ffffff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046120" y="5206680"/>
              <a:ext cx="1189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ffffff"/>
                  </a:solidFill>
                  <a:latin typeface="Arial"/>
                </a:rPr>
                <a:t>Flo </a:t>
              </a:r>
              <a:r>
                <a:rPr b="1" i="1" lang="fr-FR" sz="1200" spc="-1" strike="noStrike">
                  <a:solidFill>
                    <a:srgbClr val="ffffff"/>
                  </a:solidFill>
                  <a:latin typeface="Arial"/>
                </a:rPr>
                <a:t>vr2 : pvr2</a:t>
              </a:r>
              <a:r>
                <a:rPr b="1" i="1" lang="fr-FR" sz="1200" spc="-1" strike="noStrike" baseline="30000">
                  <a:solidFill>
                    <a:srgbClr val="ffffff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425520" y="611280"/>
            <a:ext cx="2938680" cy="4923000"/>
            <a:chOff x="425520" y="611280"/>
            <a:chExt cx="2938680" cy="4923000"/>
          </a:xfrm>
        </p:grpSpPr>
        <p:sp>
          <p:nvSpPr>
            <p:cNvPr id="60" name=""/>
            <p:cNvSpPr/>
            <p:nvPr/>
          </p:nvSpPr>
          <p:spPr>
            <a:xfrm rot="19056600">
              <a:off x="430200" y="3307680"/>
              <a:ext cx="1295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n inoculated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"/>
            <p:cNvGrpSpPr/>
            <p:nvPr/>
          </p:nvGrpSpPr>
          <p:grpSpPr>
            <a:xfrm>
              <a:off x="425520" y="611280"/>
              <a:ext cx="2938680" cy="4923000"/>
              <a:chOff x="425520" y="611280"/>
              <a:chExt cx="2938680" cy="4923000"/>
            </a:xfrm>
          </p:grpSpPr>
          <p:graphicFrame>
            <p:nvGraphicFramePr>
              <p:cNvPr id="62" name=""/>
              <p:cNvGraphicFramePr/>
              <p:nvPr/>
            </p:nvGraphicFramePr>
            <p:xfrm>
              <a:off x="1114560" y="959040"/>
              <a:ext cx="2158920" cy="2158920"/>
            </p:xfrm>
            <a:graphic>
              <a:graphicData uri="http://schemas.openxmlformats.org/presentationml/2006/ole">
                <p:oleObj progId="Excel.Sheet.12" r:id="rId4" spid="">
                  <p:embed/>
                  <p:pic>
                    <p:nvPicPr>
                      <p:cNvPr id="63" name="" descr=""/>
                      <p:cNvPicPr/>
                      <p:nvPr/>
                    </p:nvPicPr>
                    <p:blipFill>
                      <a:blip r:embed="rId5"/>
                      <a:stretch/>
                    </p:blipFill>
                    <p:spPr>
                      <a:xfrm>
                        <a:off x="1114560" y="959040"/>
                        <a:ext cx="2158920" cy="21589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64" name=""/>
              <p:cNvSpPr/>
              <p:nvPr/>
            </p:nvSpPr>
            <p:spPr>
              <a:xfrm>
                <a:off x="838440" y="2211480"/>
                <a:ext cx="326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865440" y="1509840"/>
                <a:ext cx="349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865440" y="854280"/>
                <a:ext cx="349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V="1">
                <a:off x="1147680" y="99216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425520" y="1098720"/>
                <a:ext cx="379440" cy="1797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TEV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HA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141560" y="1068480"/>
                <a:ext cx="21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flipV="1">
                <a:off x="3202200" y="1058400"/>
                <a:ext cx="0" cy="201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rot="19056600">
                <a:off x="1170000" y="3228480"/>
                <a:ext cx="10080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noculated 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rot="19056600">
                <a:off x="1400040" y="3351960"/>
                <a:ext cx="1512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Yolo Wonde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rot="19056600">
                <a:off x="1955880" y="3420360"/>
                <a:ext cx="1512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lorida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r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752400" y="611280"/>
                <a:ext cx="61452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O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0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114560" y="2830680"/>
                <a:ext cx="2158920" cy="0"/>
              </a:xfrm>
              <a:prstGeom prst="line">
                <a:avLst/>
              </a:prstGeom>
              <a:ln w="28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6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1042920" y="4114800"/>
                <a:ext cx="2159280" cy="1392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7" name=""/>
              <p:cNvSpPr/>
              <p:nvPr/>
            </p:nvSpPr>
            <p:spPr>
              <a:xfrm>
                <a:off x="1987560" y="4124520"/>
                <a:ext cx="0" cy="1368360"/>
              </a:xfrm>
              <a:prstGeom prst="line">
                <a:avLst/>
              </a:prstGeom>
              <a:ln w="284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993960" y="5238720"/>
                <a:ext cx="936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"/>
                  </a:rPr>
                  <a:t>YW : </a:t>
                </a:r>
                <a:r>
                  <a:rPr b="1" i="1" lang="en-US" sz="1200" spc="-1" strike="noStrike">
                    <a:solidFill>
                      <a:srgbClr val="ffffff"/>
                    </a:solidFill>
                    <a:latin typeface="Arial"/>
                  </a:rPr>
                  <a:t>pvr2</a:t>
                </a:r>
                <a:r>
                  <a:rPr b="1" i="1" lang="en-US" sz="1200" spc="-1" strike="noStrike" baseline="30000">
                    <a:solidFill>
                      <a:srgbClr val="ffffff"/>
                    </a:solidFill>
                    <a:latin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946160" y="5257800"/>
                <a:ext cx="1189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200" spc="-1" strike="noStrike">
                    <a:solidFill>
                      <a:srgbClr val="ffffff"/>
                    </a:solidFill>
                    <a:latin typeface="Arial"/>
                  </a:rPr>
                  <a:t>Flo </a:t>
                </a:r>
                <a:r>
                  <a:rPr b="1" i="1" lang="fr-FR" sz="1200" spc="-1" strike="noStrike">
                    <a:solidFill>
                      <a:srgbClr val="ffffff"/>
                    </a:solidFill>
                    <a:latin typeface="Arial"/>
                  </a:rPr>
                  <a:t>vr2 : pvr2</a:t>
                </a:r>
                <a:r>
                  <a:rPr b="1" i="1" lang="fr-FR" sz="1200" spc="-1" strike="noStrike" baseline="30000">
                    <a:solidFill>
                      <a:srgbClr val="ffffff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80" name=""/>
          <p:cNvSpPr/>
          <p:nvPr/>
        </p:nvSpPr>
        <p:spPr>
          <a:xfrm>
            <a:off x="333360" y="5869080"/>
            <a:ext cx="6120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. S2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ontrol test of TEV susceptibility on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Capsicum annuum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Yolo Wonder and Florida VR2 accessio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lants were mechanically inoculated with TEV HAT or TEV CAA10 at the cotyledon stage and assayed for viral coat accumulation by ELISA at 24 dpi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2T08:13:14Z</dcterms:created>
  <dc:creator>jlgallois</dc:creator>
  <dc:description/>
  <dc:language>en-US</dc:language>
  <cp:lastModifiedBy>jlgallois</cp:lastModifiedBy>
  <dcterms:modified xsi:type="dcterms:W3CDTF">2014-01-16T20:36:16Z</dcterms:modified>
  <cp:revision>7</cp:revision>
  <dc:subject/>
  <dc:title>Diapositive 1</dc:title>
</cp:coreProperties>
</file>